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3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0" y="0"/>
            <a:ext cx="672489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5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/>
              <a:t>HIF-1 direct targets </a:t>
            </a:r>
            <a:r>
              <a:rPr lang="en-US" sz="1000" b="1" dirty="0" err="1"/>
              <a:t>ChIP-seq</a:t>
            </a:r>
            <a:r>
              <a:rPr lang="en-US" sz="1000" b="1"/>
              <a:t> IGB signals 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5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minimum number for the y-axis scale was the normalized average input tag count, and the maximum number was the averag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unt (S9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ble). The WIG file for IGB was provided in GEO database (accession number </a:t>
            </a:r>
            <a:r>
              <a:rPr lang="en-US" sz="1000" dirty="0"/>
              <a:t>GSE22884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959910"/>
            <a:ext cx="1704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03F9.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801" y="3600792"/>
            <a:ext cx="1214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madd-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5875" y="6257816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ank-1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750" y="1181314"/>
            <a:ext cx="4790769" cy="232615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2237145" y="2898074"/>
            <a:ext cx="875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03F9.1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058" y="3812023"/>
            <a:ext cx="4790769" cy="2326154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2569134" y="5538751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madd-2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058" y="6624490"/>
            <a:ext cx="4790769" cy="2326154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2569134" y="8066841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ank-1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280409" y="1171146"/>
            <a:ext cx="1152195" cy="1421772"/>
            <a:chOff x="470526" y="6079802"/>
            <a:chExt cx="1152195" cy="1421772"/>
          </a:xfrm>
        </p:grpSpPr>
        <p:sp>
          <p:nvSpPr>
            <p:cNvPr id="29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280409" y="3845260"/>
            <a:ext cx="1152195" cy="1421772"/>
            <a:chOff x="470526" y="6079802"/>
            <a:chExt cx="1152195" cy="1421772"/>
          </a:xfrm>
        </p:grpSpPr>
        <p:sp>
          <p:nvSpPr>
            <p:cNvPr id="4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280409" y="6597144"/>
            <a:ext cx="1152195" cy="1421772"/>
            <a:chOff x="470526" y="6079802"/>
            <a:chExt cx="1152195" cy="1421772"/>
          </a:xfrm>
        </p:grpSpPr>
        <p:sp>
          <p:nvSpPr>
            <p:cNvPr id="53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glb-3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7" y="2645167"/>
            <a:ext cx="1139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2H11.4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202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16.4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16.2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340" y="224153"/>
            <a:ext cx="4790769" cy="232615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2107260" y="1654885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glb-3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329" y="2853860"/>
            <a:ext cx="479076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935024" y="4743081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2H11.4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489" y="5619895"/>
            <a:ext cx="4790769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585724" y="7521117"/>
            <a:ext cx="883109" cy="247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sp-16.41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107260" y="7333041"/>
            <a:ext cx="744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sp-16.2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301387" y="181606"/>
            <a:ext cx="1152195" cy="1421772"/>
            <a:chOff x="470526" y="6079802"/>
            <a:chExt cx="1152195" cy="1421772"/>
          </a:xfrm>
        </p:grpSpPr>
        <p:sp>
          <p:nvSpPr>
            <p:cNvPr id="4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03107" y="2891388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01387" y="5619895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2346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02H5.1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H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rg-1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I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rh-169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582" y="273151"/>
            <a:ext cx="4790769" cy="232615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3125971" y="2171275"/>
            <a:ext cx="1249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02H5.11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732" y="2835458"/>
            <a:ext cx="4790769" cy="2326154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3920722" y="4681415"/>
            <a:ext cx="7037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rg-1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5681734"/>
            <a:ext cx="4790769" cy="232615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403498" y="756194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rh-169</a:t>
            </a:r>
          </a:p>
        </p:txBody>
      </p:sp>
      <p:grpSp>
        <p:nvGrpSpPr>
          <p:cNvPr id="31" name="Group 30"/>
          <p:cNvGrpSpPr/>
          <p:nvPr/>
        </p:nvGrpSpPr>
        <p:grpSpPr>
          <a:xfrm>
            <a:off x="302248" y="273151"/>
            <a:ext cx="1152195" cy="1421772"/>
            <a:chOff x="470526" y="6079802"/>
            <a:chExt cx="1152195" cy="1421772"/>
          </a:xfrm>
        </p:grpSpPr>
        <p:sp>
          <p:nvSpPr>
            <p:cNvPr id="3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54513" y="2789025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73727" y="5671249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4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J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rx-117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nc-2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ol-16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157" y="249663"/>
            <a:ext cx="4790769" cy="2326154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3952966" y="2081168"/>
            <a:ext cx="730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rx-117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635" y="2851961"/>
            <a:ext cx="4790769" cy="232615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3119877" y="4423139"/>
            <a:ext cx="8793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nc-23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5726793"/>
            <a:ext cx="4790769" cy="2326154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3334605" y="7589535"/>
            <a:ext cx="6646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ol-162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232904" y="180313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302248" y="2821618"/>
            <a:ext cx="1152195" cy="1421772"/>
            <a:chOff x="470526" y="6079802"/>
            <a:chExt cx="1152195" cy="1421772"/>
          </a:xfrm>
        </p:grpSpPr>
        <p:sp>
          <p:nvSpPr>
            <p:cNvPr id="4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98481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268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M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9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N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pr-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1137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O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hr-29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73" y="234839"/>
            <a:ext cx="479076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170112" y="2110583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90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73" y="2975562"/>
            <a:ext cx="4790769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3465182" y="4865903"/>
            <a:ext cx="796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pr-3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248" y="5712437"/>
            <a:ext cx="4790769" cy="2326154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1823163" y="7583478"/>
            <a:ext cx="881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hr-291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02248" y="179173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18704" y="2928952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410734" y="5705417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8162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P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rw-5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Q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fbxb-117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1137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R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5C9.6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06" y="247496"/>
            <a:ext cx="479076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031215" y="2110583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rw-5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588" y="2912234"/>
            <a:ext cx="4790769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886448" y="4774416"/>
            <a:ext cx="796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fbxb-117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657" y="5670544"/>
            <a:ext cx="4790769" cy="2326154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2087446" y="7548753"/>
            <a:ext cx="881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5C9.6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251303" y="237439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251303" y="2897431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43655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18129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S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19B2.5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365" y="229936"/>
            <a:ext cx="479076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029933" y="2077428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19B2.5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251303" y="229936"/>
            <a:ext cx="1152195" cy="1421772"/>
            <a:chOff x="470526" y="6079802"/>
            <a:chExt cx="1152195" cy="1421772"/>
          </a:xfrm>
        </p:grpSpPr>
        <p:sp>
          <p:nvSpPr>
            <p:cNvPr id="1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6016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</TotalTime>
  <Words>307</Words>
  <Application>Microsoft Office PowerPoint</Application>
  <PresentationFormat>On-screen Show (4:3)</PresentationFormat>
  <Paragraphs>11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60</cp:revision>
  <cp:lastPrinted>2023-01-23T06:24:09Z</cp:lastPrinted>
  <dcterms:created xsi:type="dcterms:W3CDTF">2023-01-23T06:15:50Z</dcterms:created>
  <dcterms:modified xsi:type="dcterms:W3CDTF">2023-10-23T07:45:43Z</dcterms:modified>
</cp:coreProperties>
</file>